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660"/>
  </p:normalViewPr>
  <p:slideViewPr>
    <p:cSldViewPr snapToGrid="0">
      <p:cViewPr varScale="1">
        <p:scale>
          <a:sx n="88" d="100"/>
          <a:sy n="88" d="100"/>
        </p:scale>
        <p:origin x="25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良介 松田" userId="f1b315a06fc69b58" providerId="LiveId" clId="{FCDE0457-7C18-4AFC-B8F2-E13FB0736C59}"/>
    <pc:docChg chg="undo custSel delSld modSld">
      <pc:chgData name="良介 松田" userId="f1b315a06fc69b58" providerId="LiveId" clId="{FCDE0457-7C18-4AFC-B8F2-E13FB0736C59}" dt="2026-05-30T05:51:39.089" v="46" actId="20577"/>
      <pc:docMkLst>
        <pc:docMk/>
      </pc:docMkLst>
      <pc:sldChg chg="addSp modSp mod">
        <pc:chgData name="良介 松田" userId="f1b315a06fc69b58" providerId="LiveId" clId="{FCDE0457-7C18-4AFC-B8F2-E13FB0736C59}" dt="2026-05-30T05:51:39.089" v="46" actId="20577"/>
        <pc:sldMkLst>
          <pc:docMk/>
          <pc:sldMk cId="742405898" sldId="257"/>
        </pc:sldMkLst>
        <pc:spChg chg="add mod">
          <ac:chgData name="良介 松田" userId="f1b315a06fc69b58" providerId="LiveId" clId="{FCDE0457-7C18-4AFC-B8F2-E13FB0736C59}" dt="2026-05-30T05:51:39.089" v="46" actId="20577"/>
          <ac:spMkLst>
            <pc:docMk/>
            <pc:sldMk cId="742405898" sldId="257"/>
            <ac:spMk id="3" creationId="{33F80674-5BFB-3B7A-F0FB-28A126FFAF2C}"/>
          </ac:spMkLst>
        </pc:spChg>
        <pc:spChg chg="mod">
          <ac:chgData name="良介 松田" userId="f1b315a06fc69b58" providerId="LiveId" clId="{FCDE0457-7C18-4AFC-B8F2-E13FB0736C59}" dt="2026-05-30T05:50:22.598" v="20" actId="164"/>
          <ac:spMkLst>
            <pc:docMk/>
            <pc:sldMk cId="742405898" sldId="257"/>
            <ac:spMk id="9" creationId="{10B418B3-677D-0248-1935-9EF887A4EA8D}"/>
          </ac:spMkLst>
        </pc:spChg>
        <pc:spChg chg="mod">
          <ac:chgData name="良介 松田" userId="f1b315a06fc69b58" providerId="LiveId" clId="{FCDE0457-7C18-4AFC-B8F2-E13FB0736C59}" dt="2026-05-30T05:50:22.598" v="20" actId="164"/>
          <ac:spMkLst>
            <pc:docMk/>
            <pc:sldMk cId="742405898" sldId="257"/>
            <ac:spMk id="10" creationId="{59D34DD0-3789-DC28-B457-87B6A6EA4DE3}"/>
          </ac:spMkLst>
        </pc:spChg>
        <pc:spChg chg="mod">
          <ac:chgData name="良介 松田" userId="f1b315a06fc69b58" providerId="LiveId" clId="{FCDE0457-7C18-4AFC-B8F2-E13FB0736C59}" dt="2026-05-30T05:50:22.598" v="20" actId="164"/>
          <ac:spMkLst>
            <pc:docMk/>
            <pc:sldMk cId="742405898" sldId="257"/>
            <ac:spMk id="11" creationId="{B8090519-6514-DD21-94AF-E16C51C84C68}"/>
          </ac:spMkLst>
        </pc:spChg>
        <pc:spChg chg="mod">
          <ac:chgData name="良介 松田" userId="f1b315a06fc69b58" providerId="LiveId" clId="{FCDE0457-7C18-4AFC-B8F2-E13FB0736C59}" dt="2026-05-30T05:50:22.598" v="20" actId="164"/>
          <ac:spMkLst>
            <pc:docMk/>
            <pc:sldMk cId="742405898" sldId="257"/>
            <ac:spMk id="12" creationId="{612824EB-F0E9-757B-3E64-283882CE1C55}"/>
          </ac:spMkLst>
        </pc:spChg>
        <pc:grpChg chg="add mod">
          <ac:chgData name="良介 松田" userId="f1b315a06fc69b58" providerId="LiveId" clId="{FCDE0457-7C18-4AFC-B8F2-E13FB0736C59}" dt="2026-05-30T05:50:22.598" v="20" actId="164"/>
          <ac:grpSpMkLst>
            <pc:docMk/>
            <pc:sldMk cId="742405898" sldId="257"/>
            <ac:grpSpMk id="2" creationId="{597186D6-71DC-8C4E-37D7-0A9EE6EE6B67}"/>
          </ac:grpSpMkLst>
        </pc:grpChg>
        <pc:grpChg chg="mod">
          <ac:chgData name="良介 松田" userId="f1b315a06fc69b58" providerId="LiveId" clId="{FCDE0457-7C18-4AFC-B8F2-E13FB0736C59}" dt="2026-05-30T05:50:22.598" v="20" actId="164"/>
          <ac:grpSpMkLst>
            <pc:docMk/>
            <pc:sldMk cId="742405898" sldId="257"/>
            <ac:grpSpMk id="5" creationId="{ECAB0E86-D928-BFC6-166C-3EB00C12CE32}"/>
          </ac:grpSpMkLst>
        </pc:grpChg>
        <pc:picChg chg="mod">
          <ac:chgData name="良介 松田" userId="f1b315a06fc69b58" providerId="LiveId" clId="{FCDE0457-7C18-4AFC-B8F2-E13FB0736C59}" dt="2026-05-30T05:50:22.598" v="20" actId="164"/>
          <ac:picMkLst>
            <pc:docMk/>
            <pc:sldMk cId="742405898" sldId="257"/>
            <ac:picMk id="4" creationId="{235A183F-9DD1-BF02-47DD-A4EE08321BF9}"/>
          </ac:picMkLst>
        </pc:picChg>
      </pc:sldChg>
      <pc:sldChg chg="del">
        <pc:chgData name="良介 松田" userId="f1b315a06fc69b58" providerId="LiveId" clId="{FCDE0457-7C18-4AFC-B8F2-E13FB0736C59}" dt="2026-05-30T05:48:03.421" v="0" actId="47"/>
        <pc:sldMkLst>
          <pc:docMk/>
          <pc:sldMk cId="667677145" sldId="258"/>
        </pc:sldMkLst>
      </pc:sldChg>
      <pc:sldChg chg="addSp modSp mod">
        <pc:chgData name="良介 松田" userId="f1b315a06fc69b58" providerId="LiveId" clId="{FCDE0457-7C18-4AFC-B8F2-E13FB0736C59}" dt="2026-05-30T05:51:31.411" v="43" actId="20577"/>
        <pc:sldMkLst>
          <pc:docMk/>
          <pc:sldMk cId="617048545" sldId="259"/>
        </pc:sldMkLst>
        <pc:spChg chg="mod">
          <ac:chgData name="良介 松田" userId="f1b315a06fc69b58" providerId="LiveId" clId="{FCDE0457-7C18-4AFC-B8F2-E13FB0736C59}" dt="2026-05-30T05:49:36.848" v="19" actId="164"/>
          <ac:spMkLst>
            <pc:docMk/>
            <pc:sldMk cId="617048545" sldId="259"/>
            <ac:spMk id="3" creationId="{88BEB9D7-978F-39A8-12CE-198FA588F5AA}"/>
          </ac:spMkLst>
        </pc:spChg>
        <pc:spChg chg="add mod">
          <ac:chgData name="良介 松田" userId="f1b315a06fc69b58" providerId="LiveId" clId="{FCDE0457-7C18-4AFC-B8F2-E13FB0736C59}" dt="2026-05-30T05:51:31.411" v="43" actId="20577"/>
          <ac:spMkLst>
            <pc:docMk/>
            <pc:sldMk cId="617048545" sldId="259"/>
            <ac:spMk id="11" creationId="{33C6F945-1CA0-0400-A976-BACE6D6FA9DD}"/>
          </ac:spMkLst>
        </pc:spChg>
        <pc:grpChg chg="add mod">
          <ac:chgData name="良介 松田" userId="f1b315a06fc69b58" providerId="LiveId" clId="{FCDE0457-7C18-4AFC-B8F2-E13FB0736C59}" dt="2026-05-30T05:49:36.848" v="19" actId="164"/>
          <ac:grpSpMkLst>
            <pc:docMk/>
            <pc:sldMk cId="617048545" sldId="259"/>
            <ac:grpSpMk id="10" creationId="{D5339BE2-6C5B-DEBD-4E28-03D9CBE40683}"/>
          </ac:grpSpMkLst>
        </pc:grpChg>
        <pc:picChg chg="mod">
          <ac:chgData name="良介 松田" userId="f1b315a06fc69b58" providerId="LiveId" clId="{FCDE0457-7C18-4AFC-B8F2-E13FB0736C59}" dt="2026-05-30T05:49:36.848" v="19" actId="164"/>
          <ac:picMkLst>
            <pc:docMk/>
            <pc:sldMk cId="617048545" sldId="259"/>
            <ac:picMk id="5" creationId="{3567EA8C-A256-958E-3201-D1F7AAE09286}"/>
          </ac:picMkLst>
        </pc:picChg>
        <pc:picChg chg="mod">
          <ac:chgData name="良介 松田" userId="f1b315a06fc69b58" providerId="LiveId" clId="{FCDE0457-7C18-4AFC-B8F2-E13FB0736C59}" dt="2026-05-30T05:49:36.848" v="19" actId="164"/>
          <ac:picMkLst>
            <pc:docMk/>
            <pc:sldMk cId="617048545" sldId="259"/>
            <ac:picMk id="7" creationId="{83B292DA-0D2A-209F-0148-0396DF2F4DCC}"/>
          </ac:picMkLst>
        </pc:picChg>
        <pc:picChg chg="mod">
          <ac:chgData name="良介 松田" userId="f1b315a06fc69b58" providerId="LiveId" clId="{FCDE0457-7C18-4AFC-B8F2-E13FB0736C59}" dt="2026-05-30T05:49:36.848" v="19" actId="164"/>
          <ac:picMkLst>
            <pc:docMk/>
            <pc:sldMk cId="617048545" sldId="259"/>
            <ac:picMk id="9" creationId="{CFE207FD-978E-2050-8385-5F6D1767DA13}"/>
          </ac:picMkLst>
        </pc:picChg>
      </pc:sldChg>
      <pc:sldChg chg="del">
        <pc:chgData name="良介 松田" userId="f1b315a06fc69b58" providerId="LiveId" clId="{FCDE0457-7C18-4AFC-B8F2-E13FB0736C59}" dt="2026-05-30T05:48:04.143" v="1" actId="47"/>
        <pc:sldMkLst>
          <pc:docMk/>
          <pc:sldMk cId="399333601" sldId="260"/>
        </pc:sldMkLst>
      </pc:sldChg>
      <pc:sldChg chg="del">
        <pc:chgData name="良介 松田" userId="f1b315a06fc69b58" providerId="LiveId" clId="{FCDE0457-7C18-4AFC-B8F2-E13FB0736C59}" dt="2026-05-30T05:48:05.049" v="2" actId="47"/>
        <pc:sldMkLst>
          <pc:docMk/>
          <pc:sldMk cId="1435340920" sldId="26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42A0EC-BFED-6662-F749-EE7C9D5CEF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597708B-C551-0085-C74C-09E1D7BBDB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8F1FD4-ECD5-35A8-B583-745F5E482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270457-5C3A-AD4F-6E1C-F42EA59EA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B72821-B323-0402-7594-1950FBDD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333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126F8A-77AB-CC80-48BC-BF0E0163DF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A31407-3773-1C38-717A-13A8A55ECD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2F748B-0E52-914E-ED67-D59ACD895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422E53-83B8-62F4-C54C-EFDD589C1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06E037-CA85-F94D-DDD2-3C5C5FA0D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319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76CB5B4-2B84-BD18-4013-BB2DDDBBBE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C30470A-1217-68C6-BDFA-CA0D603F86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3538DF-D0F1-8CFB-C670-4D4BEF1BB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F4B362-F8F3-9DBE-ED54-5D2E332EB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EA823D-2F42-3898-9EE2-65558110F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83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31D11A-2386-D3FB-9B74-1EFAE23AC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D09567-8BFD-0894-5DAA-3DE6B7FE23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953FE3-427E-8ACD-916F-3E3D5DE07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5E3765-F72C-65CA-7011-057641598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27E075-03B2-D4F6-CEC8-F20680844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517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5D0D0E-43DC-EE83-F93E-27A16BF3D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979C396-5FB9-0D55-DEAE-10503E1D4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5D79AA-2CC1-7EA8-6261-511155EB5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613031-2528-43A2-10F1-E83F05D8A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6FE1DD-DFFF-A685-474D-CB06ACBB3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96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CE446B-A34B-C6C6-4CAC-7F3E9CB7B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D31C525-7816-57E7-C419-6D430BD753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7EB084A-3B75-D195-DF09-E0F3E547C3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8D39EB6-87C2-D06F-1D9E-F5F8788DE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3D47203-EBD5-80A6-3CCD-3BEE90DE4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33BBC6-2407-0F3B-23C0-1D6A5F2E5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13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C4B17D-C0D1-F82E-BB32-B40CA82F79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EED42D-A6CB-0638-0FF9-483E67669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80FD40-2EFB-5667-5059-04F652654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AE30998-B3B9-8B3B-9F74-4948A109E4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799B56E-0126-D3D3-05A9-1D803F8C0C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1BB6708-49C0-D83C-076F-B4C641075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08FDDE5-3290-BB92-E602-4CD32061F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7EBA32F-59FF-0F54-38CF-135A284F5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6589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0F8DF3-BCA6-AE08-B14E-BA414AC31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8AC6C8B-493D-2511-1F76-6D26ABB71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F9B218-9333-702A-40B4-DB0531D13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5C2C804-3021-2462-6583-2972D1D18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74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019CE08-36A1-CD5C-BEDD-E9A611C57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F8F2741-C518-3718-7F00-8438FDA79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C9B6001-964B-B722-62FE-FE6A99D56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4179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9A29CF-BB21-6A70-770B-2F21A5F5A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0ECE3D5-A008-B022-C05B-991AEADC5E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3EFEEDC-0300-892F-CE27-7EAC7E9289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EB71659-531A-3695-8BB9-5633ECE1D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327AC0-A5E7-6B74-94C9-FE52B4DDF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D6803D1-7A7B-DA2C-0A82-946D9D7CC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774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A07169-4418-5909-0F78-5E5315353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58E024E-B665-1E5E-506F-D49365F8F8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B89555-4734-323A-7BE6-A9A0E9F344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D184517-CB5C-D8C3-E73F-ACC7D9CB8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AFFB1F-4406-7CB2-4354-C3E3EE113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24E98C-8CC3-4048-55EA-6E6B981B6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637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EA07CED-C7FC-D034-022E-39A46D1F05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66C10E-1CB3-057A-C2DE-7A49B34FA4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A47E20-FC4F-A5DB-351A-6AD426C9D8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21A06D-7908-4955-89B0-9E0C1B74D1DF}" type="datetimeFigureOut">
              <a:rPr kumimoji="1" lang="ja-JP" altLang="en-US" smtClean="0"/>
              <a:t>2026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6802D0-989F-B98B-4890-54F74D7B32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615183-8E4C-D906-3AEE-3923C17368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197052-35EB-467F-9F4C-7B816E2E64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980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D5339BE2-6C5B-DEBD-4E28-03D9CBE40683}"/>
              </a:ext>
            </a:extLst>
          </p:cNvPr>
          <p:cNvGrpSpPr/>
          <p:nvPr/>
        </p:nvGrpSpPr>
        <p:grpSpPr>
          <a:xfrm>
            <a:off x="491428" y="1789257"/>
            <a:ext cx="11299201" cy="4932291"/>
            <a:chOff x="491428" y="1789257"/>
            <a:chExt cx="11299201" cy="4932291"/>
          </a:xfrm>
        </p:grpSpPr>
        <p:sp>
          <p:nvSpPr>
            <p:cNvPr id="3" name="AutoShape 4" descr="画像のプレビュー">
              <a:extLst>
                <a:ext uri="{FF2B5EF4-FFF2-40B4-BE49-F238E27FC236}">
                  <a16:creationId xmlns:a16="http://schemas.microsoft.com/office/drawing/2014/main" id="{88BEB9D7-978F-39A8-12CE-198FA588F5A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5943599" y="3276599"/>
              <a:ext cx="3444949" cy="34449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3567EA8C-A256-958E-3201-D1F7AAE092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428" y="1789259"/>
              <a:ext cx="3576308" cy="3783861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83B292DA-0D2A-209F-0148-0396DF2F4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67736" y="1789257"/>
              <a:ext cx="3861446" cy="3861446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CFE207FD-978E-2050-8385-5F6D1767DA1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9183" y="1789258"/>
              <a:ext cx="3861446" cy="3861446"/>
            </a:xfrm>
            <a:prstGeom prst="rect">
              <a:avLst/>
            </a:prstGeom>
          </p:spPr>
        </p:pic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3C6F945-1CA0-0400-A976-BACE6D6FA9DD}"/>
              </a:ext>
            </a:extLst>
          </p:cNvPr>
          <p:cNvSpPr txBox="1"/>
          <p:nvPr/>
        </p:nvSpPr>
        <p:spPr>
          <a:xfrm>
            <a:off x="606056" y="776177"/>
            <a:ext cx="10445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upplementary figure S1</a:t>
            </a:r>
            <a:r>
              <a:rPr lang="en-US" altLang="ja-JP" sz="1400" dirty="0"/>
              <a:t>:</a:t>
            </a:r>
            <a:r>
              <a:rPr lang="zh-CN" altLang="en-US" sz="1400" dirty="0"/>
              <a:t> </a:t>
            </a:r>
            <a:r>
              <a:rPr lang="en-US" altLang="zh-CN" sz="1400" dirty="0"/>
              <a:t>A supplementary calibration-style assessment at 12, 24, and 36 months in both the training cohort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617048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97186D6-71DC-8C4E-37D7-0A9EE6EE6B67}"/>
              </a:ext>
            </a:extLst>
          </p:cNvPr>
          <p:cNvGrpSpPr/>
          <p:nvPr/>
        </p:nvGrpSpPr>
        <p:grpSpPr>
          <a:xfrm>
            <a:off x="1034903" y="228600"/>
            <a:ext cx="6400800" cy="6400800"/>
            <a:chOff x="1034903" y="228600"/>
            <a:chExt cx="6400800" cy="6400800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35A183F-9DD1-BF02-47DD-A4EE08321B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34903" y="228600"/>
              <a:ext cx="6400800" cy="6400800"/>
            </a:xfrm>
            <a:prstGeom prst="rect">
              <a:avLst/>
            </a:prstGeom>
          </p:spPr>
        </p:pic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ECAB0E86-D928-BFC6-166C-3EB00C12CE32}"/>
                </a:ext>
              </a:extLst>
            </p:cNvPr>
            <p:cNvGrpSpPr/>
            <p:nvPr/>
          </p:nvGrpSpPr>
          <p:grpSpPr>
            <a:xfrm>
              <a:off x="1164146" y="5887400"/>
              <a:ext cx="1080899" cy="724669"/>
              <a:chOff x="-1728817" y="7425258"/>
              <a:chExt cx="1080899" cy="724669"/>
            </a:xfrm>
          </p:grpSpPr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2E16DA1A-9D30-F5C0-1338-ECF78AFCFBDD}"/>
                  </a:ext>
                </a:extLst>
              </p:cNvPr>
              <p:cNvSpPr txBox="1"/>
              <p:nvPr/>
            </p:nvSpPr>
            <p:spPr>
              <a:xfrm>
                <a:off x="-1728817" y="7425258"/>
                <a:ext cx="10808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oup</a:t>
                </a:r>
                <a:r>
                  <a:rPr lang="ja-JP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723B1670-5D2C-7576-4DD3-579E19DC47D0}"/>
                  </a:ext>
                </a:extLst>
              </p:cNvPr>
              <p:cNvSpPr txBox="1"/>
              <p:nvPr/>
            </p:nvSpPr>
            <p:spPr>
              <a:xfrm>
                <a:off x="-1728817" y="7649093"/>
                <a:ext cx="10808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oup</a:t>
                </a:r>
                <a:r>
                  <a:rPr lang="ja-JP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7314AC8D-169F-C754-3C08-2945E31BFFB6}"/>
                  </a:ext>
                </a:extLst>
              </p:cNvPr>
              <p:cNvSpPr txBox="1"/>
              <p:nvPr/>
            </p:nvSpPr>
            <p:spPr>
              <a:xfrm>
                <a:off x="-1728817" y="7872928"/>
                <a:ext cx="10808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oup</a:t>
                </a:r>
                <a:r>
                  <a:rPr lang="ja-JP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0B418B3-677D-0248-1935-9EF887A4EA8D}"/>
                </a:ext>
              </a:extLst>
            </p:cNvPr>
            <p:cNvSpPr txBox="1"/>
            <p:nvPr/>
          </p:nvSpPr>
          <p:spPr>
            <a:xfrm>
              <a:off x="5938092" y="910542"/>
              <a:ext cx="149761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59D34DD0-3789-DC28-B457-87B6A6EA4DE3}"/>
                </a:ext>
              </a:extLst>
            </p:cNvPr>
            <p:cNvSpPr txBox="1"/>
            <p:nvPr/>
          </p:nvSpPr>
          <p:spPr>
            <a:xfrm>
              <a:off x="6778656" y="1409042"/>
              <a:ext cx="353690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8090519-6514-DD21-94AF-E16C51C84C68}"/>
                </a:ext>
              </a:extLst>
            </p:cNvPr>
            <p:cNvSpPr txBox="1"/>
            <p:nvPr/>
          </p:nvSpPr>
          <p:spPr>
            <a:xfrm>
              <a:off x="6787622" y="1615098"/>
              <a:ext cx="353690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612824EB-F0E9-757B-3E64-283882CE1C55}"/>
                </a:ext>
              </a:extLst>
            </p:cNvPr>
            <p:cNvSpPr txBox="1"/>
            <p:nvPr/>
          </p:nvSpPr>
          <p:spPr>
            <a:xfrm>
              <a:off x="6787622" y="1191936"/>
              <a:ext cx="353690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3F80674-5BFB-3B7A-F0FB-28A126FFAF2C}"/>
              </a:ext>
            </a:extLst>
          </p:cNvPr>
          <p:cNvSpPr txBox="1"/>
          <p:nvPr/>
        </p:nvSpPr>
        <p:spPr>
          <a:xfrm>
            <a:off x="584791" y="324269"/>
            <a:ext cx="8409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upplementary figure S2:The sensitivity analysis restricted to patients who received chemotherapy 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742405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6</TotalTime>
  <Words>44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良介 松田</dc:creator>
  <cp:lastModifiedBy>MDPI</cp:lastModifiedBy>
  <cp:revision>3</cp:revision>
  <dcterms:created xsi:type="dcterms:W3CDTF">2026-05-26T23:41:43Z</dcterms:created>
  <dcterms:modified xsi:type="dcterms:W3CDTF">2026-06-09T01:14:44Z</dcterms:modified>
</cp:coreProperties>
</file>